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8" d="100"/>
          <a:sy n="68" d="100"/>
        </p:scale>
        <p:origin x="-1482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684F-F8E9-4F35-BF16-A8EE0BC787D9}" type="datetimeFigureOut">
              <a:rPr lang="en-US" smtClean="0"/>
              <a:pPr/>
              <a:t>7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17A21-216D-482E-9A8A-1F102CDC21D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684F-F8E9-4F35-BF16-A8EE0BC787D9}" type="datetimeFigureOut">
              <a:rPr lang="en-US" smtClean="0"/>
              <a:pPr/>
              <a:t>7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17A21-216D-482E-9A8A-1F102CDC21D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684F-F8E9-4F35-BF16-A8EE0BC787D9}" type="datetimeFigureOut">
              <a:rPr lang="en-US" smtClean="0"/>
              <a:pPr/>
              <a:t>7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17A21-216D-482E-9A8A-1F102CDC21D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684F-F8E9-4F35-BF16-A8EE0BC787D9}" type="datetimeFigureOut">
              <a:rPr lang="en-US" smtClean="0"/>
              <a:pPr/>
              <a:t>7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17A21-216D-482E-9A8A-1F102CDC21D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684F-F8E9-4F35-BF16-A8EE0BC787D9}" type="datetimeFigureOut">
              <a:rPr lang="en-US" smtClean="0"/>
              <a:pPr/>
              <a:t>7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17A21-216D-482E-9A8A-1F102CDC21D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684F-F8E9-4F35-BF16-A8EE0BC787D9}" type="datetimeFigureOut">
              <a:rPr lang="en-US" smtClean="0"/>
              <a:pPr/>
              <a:t>7/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17A21-216D-482E-9A8A-1F102CDC21D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684F-F8E9-4F35-BF16-A8EE0BC787D9}" type="datetimeFigureOut">
              <a:rPr lang="en-US" smtClean="0"/>
              <a:pPr/>
              <a:t>7/1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17A21-216D-482E-9A8A-1F102CDC21D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684F-F8E9-4F35-BF16-A8EE0BC787D9}" type="datetimeFigureOut">
              <a:rPr lang="en-US" smtClean="0"/>
              <a:pPr/>
              <a:t>7/1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17A21-216D-482E-9A8A-1F102CDC21D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684F-F8E9-4F35-BF16-A8EE0BC787D9}" type="datetimeFigureOut">
              <a:rPr lang="en-US" smtClean="0"/>
              <a:pPr/>
              <a:t>7/1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17A21-216D-482E-9A8A-1F102CDC21D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684F-F8E9-4F35-BF16-A8EE0BC787D9}" type="datetimeFigureOut">
              <a:rPr lang="en-US" smtClean="0"/>
              <a:pPr/>
              <a:t>7/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17A21-216D-482E-9A8A-1F102CDC21D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1D684F-F8E9-4F35-BF16-A8EE0BC787D9}" type="datetimeFigureOut">
              <a:rPr lang="en-US" smtClean="0"/>
              <a:pPr/>
              <a:t>7/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17A21-216D-482E-9A8A-1F102CDC21D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1D684F-F8E9-4F35-BF16-A8EE0BC787D9}" type="datetimeFigureOut">
              <a:rPr lang="en-US" smtClean="0"/>
              <a:pPr/>
              <a:t>7/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F17A21-216D-482E-9A8A-1F102CDC21D0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/>
        </p:nvGraphicFramePr>
        <p:xfrm>
          <a:off x="634699" y="180536"/>
          <a:ext cx="7995475" cy="647064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923478"/>
                <a:gridCol w="3108071"/>
                <a:gridCol w="2963926"/>
              </a:tblGrid>
              <a:tr h="497742">
                <a:tc>
                  <a:txBody>
                    <a:bodyPr/>
                    <a:lstStyle/>
                    <a:p>
                      <a:pPr algn="ctr"/>
                      <a:r>
                        <a:rPr lang="en-US" sz="1600" dirty="0" smtClean="0">
                          <a:latin typeface="Arial" pitchFamily="34" charset="0"/>
                          <a:cs typeface="Arial" pitchFamily="34" charset="0"/>
                        </a:rPr>
                        <a:t>Name of the gene</a:t>
                      </a:r>
                      <a:endParaRPr lang="en-US" sz="16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 smtClean="0">
                          <a:latin typeface="Arial" pitchFamily="34" charset="0"/>
                          <a:cs typeface="Arial" pitchFamily="34" charset="0"/>
                        </a:rPr>
                        <a:t>Forward</a:t>
                      </a:r>
                      <a:r>
                        <a:rPr lang="en-US" sz="1600" baseline="0" dirty="0" smtClean="0">
                          <a:latin typeface="Arial" pitchFamily="34" charset="0"/>
                          <a:cs typeface="Arial" pitchFamily="34" charset="0"/>
                        </a:rPr>
                        <a:t> primer</a:t>
                      </a:r>
                      <a:endParaRPr lang="en-US" sz="16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 smtClean="0">
                          <a:latin typeface="Arial" pitchFamily="34" charset="0"/>
                          <a:cs typeface="Arial" pitchFamily="34" charset="0"/>
                        </a:rPr>
                        <a:t>Reverse</a:t>
                      </a:r>
                      <a:r>
                        <a:rPr lang="en-US" sz="1600" baseline="0" dirty="0" smtClean="0">
                          <a:latin typeface="Arial" pitchFamily="34" charset="0"/>
                          <a:cs typeface="Arial" pitchFamily="34" charset="0"/>
                        </a:rPr>
                        <a:t> primer</a:t>
                      </a:r>
                      <a:endParaRPr lang="en-US" sz="16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</a:tr>
              <a:tr h="497742">
                <a:tc>
                  <a:txBody>
                    <a:bodyPr/>
                    <a:lstStyle/>
                    <a:p>
                      <a:pPr algn="ctr"/>
                      <a:r>
                        <a:rPr lang="en-US" b="1" i="1" dirty="0" smtClean="0"/>
                        <a:t>GAPDH</a:t>
                      </a:r>
                      <a:endParaRPr lang="en-US" b="1" i="1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ACTTTGGTATCGTGGAAGGACT</a:t>
                      </a:r>
                      <a:endParaRPr lang="en-US" sz="1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GTAGAGGCAGGGATGATGTTCT</a:t>
                      </a:r>
                      <a:endParaRPr lang="en-US" sz="1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497742">
                <a:tc>
                  <a:txBody>
                    <a:bodyPr/>
                    <a:lstStyle/>
                    <a:p>
                      <a:pPr algn="ctr"/>
                      <a:r>
                        <a:rPr lang="en-US" b="1" i="1" dirty="0" smtClean="0"/>
                        <a:t>CAP1</a:t>
                      </a:r>
                      <a:endParaRPr lang="en-US" b="1" i="1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ATTCCCTGGATTGTGAAATAGTC</a:t>
                      </a:r>
                      <a:endParaRPr lang="en-US" sz="1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ATTAAAGTCACCGCCTTCTGTAG</a:t>
                      </a:r>
                      <a:endParaRPr lang="en-US" sz="1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497742">
                <a:tc>
                  <a:txBody>
                    <a:bodyPr/>
                    <a:lstStyle/>
                    <a:p>
                      <a:pPr algn="ctr"/>
                      <a:r>
                        <a:rPr lang="en-US" b="1" i="1" dirty="0" smtClean="0"/>
                        <a:t>NFKBIZ</a:t>
                      </a:r>
                      <a:endParaRPr lang="en-US" b="1" i="1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CCGTTTCCCTGAACACAGTT</a:t>
                      </a:r>
                      <a:endParaRPr lang="en-US" sz="1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AGAAAAGACCTGCCCTCCAT</a:t>
                      </a:r>
                      <a:endParaRPr lang="en-US" sz="1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497742">
                <a:tc>
                  <a:txBody>
                    <a:bodyPr/>
                    <a:lstStyle/>
                    <a:p>
                      <a:pPr algn="ctr"/>
                      <a:r>
                        <a:rPr lang="en-US" b="1" i="1" dirty="0" smtClean="0"/>
                        <a:t>IL6</a:t>
                      </a:r>
                      <a:endParaRPr lang="en-US" b="1" i="1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CACAGACAGCCACTCACCTC</a:t>
                      </a:r>
                      <a:endParaRPr lang="en-US" sz="1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TTTTCTGCCAGTGCCTCTTT</a:t>
                      </a:r>
                      <a:endParaRPr lang="en-US" sz="1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497742">
                <a:tc>
                  <a:txBody>
                    <a:bodyPr/>
                    <a:lstStyle/>
                    <a:p>
                      <a:pPr algn="ctr"/>
                      <a:r>
                        <a:rPr lang="en-US" b="1" i="1" dirty="0" smtClean="0"/>
                        <a:t>CSF2</a:t>
                      </a:r>
                      <a:endParaRPr lang="en-US" b="1" i="1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n-NO" sz="1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CACTGCTGCTGAGATGAATGA </a:t>
                      </a:r>
                      <a:endParaRPr lang="nn-NO" sz="1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 smtClean="0">
                          <a:latin typeface="Arial"/>
                        </a:rPr>
                        <a:t>TAATCTGGGTTGCACAGGAAG</a:t>
                      </a:r>
                      <a:r>
                        <a:rPr lang="en-US" sz="1000" b="0" i="0" u="none" strike="noStrike" dirty="0" smtClean="0">
                          <a:latin typeface="Arial"/>
                        </a:rPr>
                        <a:t> </a:t>
                      </a:r>
                      <a:endParaRPr lang="en-US" sz="1000" b="0" i="0" u="none" strike="noStrike" dirty="0">
                        <a:latin typeface="Arial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497742">
                <a:tc>
                  <a:txBody>
                    <a:bodyPr/>
                    <a:lstStyle/>
                    <a:p>
                      <a:pPr algn="ctr"/>
                      <a:r>
                        <a:rPr lang="en-US" b="1" i="1" dirty="0" smtClean="0"/>
                        <a:t>CXCL8</a:t>
                      </a:r>
                      <a:endParaRPr lang="en-US" b="1" i="1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AGTTTTTGAAGAGGGCTGAGAAT</a:t>
                      </a:r>
                      <a:endParaRPr lang="en-US" sz="1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CAACAGACCCACACAATACATGA</a:t>
                      </a:r>
                      <a:endParaRPr lang="en-US" sz="1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497742">
                <a:tc>
                  <a:txBody>
                    <a:bodyPr/>
                    <a:lstStyle/>
                    <a:p>
                      <a:pPr algn="ctr"/>
                      <a:r>
                        <a:rPr lang="en-US" b="1" i="1" dirty="0" smtClean="0"/>
                        <a:t>TNF</a:t>
                      </a:r>
                      <a:endParaRPr lang="en-US" b="1" i="1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GCTTGTTCCTCAGCCTCTTCT</a:t>
                      </a:r>
                      <a:endParaRPr lang="en-US" sz="1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GGTTTGCTACAACATGGGCTA</a:t>
                      </a:r>
                      <a:endParaRPr lang="en-US" sz="1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497742">
                <a:tc>
                  <a:txBody>
                    <a:bodyPr/>
                    <a:lstStyle/>
                    <a:p>
                      <a:pPr algn="ctr"/>
                      <a:r>
                        <a:rPr lang="en-US" b="1" i="1" dirty="0" smtClean="0"/>
                        <a:t>IL1B</a:t>
                      </a:r>
                      <a:endParaRPr lang="en-US" b="1" i="1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CCAGTGAAATGATGGCTTATTAC</a:t>
                      </a:r>
                      <a:endParaRPr lang="en-US" sz="1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CTGTAGTGGTGGTCGGAGATT</a:t>
                      </a:r>
                      <a:endParaRPr lang="en-US" sz="1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497742">
                <a:tc>
                  <a:txBody>
                    <a:bodyPr/>
                    <a:lstStyle/>
                    <a:p>
                      <a:pPr algn="ctr"/>
                      <a:r>
                        <a:rPr lang="en-US" b="1" i="1" dirty="0" smtClean="0"/>
                        <a:t>CCL7</a:t>
                      </a:r>
                      <a:endParaRPr lang="en-US" b="1" i="1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 smtClean="0">
                          <a:latin typeface="Arial"/>
                        </a:rPr>
                        <a:t>ACTTCTGTGTCTGCTGCTCACA</a:t>
                      </a:r>
                      <a:endParaRPr lang="en-US" sz="1400" b="1" i="0" u="none" strike="noStrike" dirty="0">
                        <a:latin typeface="Arial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 smtClean="0">
                          <a:latin typeface="Arial"/>
                        </a:rPr>
                        <a:t>GGACAGTGGCTACTGGTGGT</a:t>
                      </a:r>
                      <a:endParaRPr lang="en-US" sz="1400" b="1" i="0" u="none" strike="noStrike" dirty="0">
                        <a:latin typeface="Arial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497742">
                <a:tc>
                  <a:txBody>
                    <a:bodyPr/>
                    <a:lstStyle/>
                    <a:p>
                      <a:pPr algn="ctr"/>
                      <a:r>
                        <a:rPr lang="en-US" b="1" i="1" dirty="0" smtClean="0"/>
                        <a:t>CXCL5</a:t>
                      </a:r>
                      <a:endParaRPr lang="en-US" b="1" i="1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 smtClean="0">
                          <a:solidFill>
                            <a:srgbClr val="000000"/>
                          </a:solidFill>
                          <a:latin typeface="Arial" pitchFamily="34" charset="0"/>
                          <a:cs typeface="Arial" pitchFamily="34" charset="0"/>
                        </a:rPr>
                        <a:t>GCAAGGAGTTCATCCCAAAA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 smtClean="0">
                          <a:latin typeface="Arial"/>
                        </a:rPr>
                        <a:t>AAAAGGGGCTTCTGGATCAA</a:t>
                      </a:r>
                      <a:endParaRPr lang="en-US" sz="1400" b="1" i="0" u="none" strike="noStrike" dirty="0">
                        <a:latin typeface="Arial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497742">
                <a:tc>
                  <a:txBody>
                    <a:bodyPr/>
                    <a:lstStyle/>
                    <a:p>
                      <a:pPr algn="ctr"/>
                      <a:r>
                        <a:rPr lang="en-US" b="1" i="1" dirty="0" smtClean="0"/>
                        <a:t>IL18</a:t>
                      </a:r>
                      <a:endParaRPr lang="en-US" b="1" i="1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GAAAACCTGGAATCCGATTACTT</a:t>
                      </a:r>
                      <a:endParaRPr lang="en-US" sz="1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CCATACCTCTAGGCTGGCTATCT</a:t>
                      </a:r>
                      <a:endParaRPr lang="en-US" sz="1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497742">
                <a:tc>
                  <a:txBody>
                    <a:bodyPr/>
                    <a:lstStyle/>
                    <a:p>
                      <a:pPr algn="ctr"/>
                      <a:r>
                        <a:rPr lang="en-US" b="1" i="1" dirty="0" smtClean="0"/>
                        <a:t>CASP4</a:t>
                      </a:r>
                      <a:endParaRPr lang="en-US" b="1" i="1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CACAACGTGTCCTGGAGAGA</a:t>
                      </a:r>
                      <a:endParaRPr lang="en-US" sz="1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ACTTCCTCTAGGTGGCAGCA</a:t>
                      </a:r>
                      <a:endParaRPr lang="en-US" sz="1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2</TotalTime>
  <Words>44</Words>
  <Application>Microsoft Office PowerPoint</Application>
  <PresentationFormat>On-screen Show (4:3)</PresentationFormat>
  <Paragraphs>3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User</dc:creator>
  <cp:lastModifiedBy>User</cp:lastModifiedBy>
  <cp:revision>27</cp:revision>
  <dcterms:created xsi:type="dcterms:W3CDTF">2016-03-15T13:47:18Z</dcterms:created>
  <dcterms:modified xsi:type="dcterms:W3CDTF">2016-07-01T12:18:41Z</dcterms:modified>
</cp:coreProperties>
</file>